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236" y="295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8189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0922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2948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2283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7652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3156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5667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596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357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449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8452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2D8E0-F964-41BF-A5DE-255492AB02CB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8BC28-E2D8-48C1-A06C-3AC76C5D25C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859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20078" y="13611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2374745" y="136110"/>
            <a:ext cx="334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Effects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on human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cancer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cell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line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L3.6pl</a:t>
            </a:r>
            <a:endParaRPr lang="de-DE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48680" y="550394"/>
            <a:ext cx="332142" cy="314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405581" y="3440832"/>
            <a:ext cx="246626" cy="2891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405581" y="5889104"/>
            <a:ext cx="390370" cy="3432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itchFamily="34" charset="0"/>
                <a:cs typeface="Arial" pitchFamily="34" charset="0"/>
              </a:rPr>
              <a:t>C</a:t>
            </a:r>
            <a:endParaRPr lang="de-DE" sz="1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Rechteck 88"/>
          <p:cNvSpPr/>
          <p:nvPr/>
        </p:nvSpPr>
        <p:spPr>
          <a:xfrm>
            <a:off x="86811" y="8356247"/>
            <a:ext cx="6510541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: Effects of targeting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MET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3.6pl pancreatic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cancer cells.</a:t>
            </a:r>
          </a:p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cubatio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3.6pl cells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ith the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MET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hibitor INC280 has no effect on constitutive growth. When cells were stimulated with HGF, a significant improvement of growth was observed (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. This was abrogated by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MET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hibition with INC280 (*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&lt;0.05)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GF induces cancer cell motility (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&lt;0.05) that can efficiently be blocked by INC280 (*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&lt;0.05)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stitutiv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otility remains unaffected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reatment with INC280 disrupts HGF-mediated phosphorylation of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ERK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4 and 24 hours of treatment. </a:t>
            </a:r>
            <a:r>
              <a:rPr lang="en-GB" sz="1100" smtClean="0">
                <a:latin typeface="Arial" panose="020B0604020202020204" pitchFamily="34" charset="0"/>
                <a:cs typeface="Arial" panose="020B0604020202020204" pitchFamily="34" charset="0"/>
              </a:rPr>
              <a:t>Bars=SEM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1698" y="383575"/>
            <a:ext cx="4797425" cy="3346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9093" y="3730025"/>
            <a:ext cx="2505075" cy="2200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156" y="6184632"/>
            <a:ext cx="2828925" cy="198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6157913"/>
            <a:ext cx="2841625" cy="206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4080524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Office PowerPoint</Application>
  <PresentationFormat>A4-Papier (210x297 mm)</PresentationFormat>
  <Paragraphs>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 Regens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ven Arke Lang</dc:creator>
  <cp:lastModifiedBy>Sven Arke Lang</cp:lastModifiedBy>
  <cp:revision>4</cp:revision>
  <dcterms:created xsi:type="dcterms:W3CDTF">2014-07-03T17:36:59Z</dcterms:created>
  <dcterms:modified xsi:type="dcterms:W3CDTF">2014-09-06T13:48:00Z</dcterms:modified>
</cp:coreProperties>
</file>